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9" r:id="rId4"/>
    <p:sldId id="264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168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84" y="15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d553ab2fac4af41/My_Researches/RSV_severity2/Result_handling/incidence_2018083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Age-specific</a:t>
            </a:r>
            <a:r>
              <a:rPr lang="en-US" baseline="0" dirty="0"/>
              <a:t> incidence</a:t>
            </a:r>
            <a:r>
              <a:rPr lang="en-US" dirty="0"/>
              <a:t> rates of total RSV-LRTI in April 2014 – March 2015</a:t>
            </a:r>
            <a:endParaRPr lang="ja-JP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12"/>
          <c:order val="12"/>
          <c:tx>
            <c:strRef>
              <c:f>流行期別インシデンス!$P$32</c:f>
              <c:strCache>
                <c:ptCount val="1"/>
                <c:pt idx="0">
                  <c:v>RSV-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extLst>
                <c:ext xmlns:c15="http://schemas.microsoft.com/office/drawing/2012/chart" uri="{02D57815-91ED-43cb-92C2-25804820EDAC}">
                  <c15:fullRef>
                    <c15:sqref>流行期別インシデンス!$B$33:$B$53</c15:sqref>
                  </c15:fullRef>
                </c:ext>
              </c:extLst>
              <c:f>流行期別インシデンス!$B$34:$B$53</c:f>
              <c:strCache>
                <c:ptCount val="20"/>
                <c:pt idx="0">
                  <c:v>2</c:v>
                </c:pt>
                <c:pt idx="1">
                  <c:v>3–5</c:v>
                </c:pt>
                <c:pt idx="2">
                  <c:v>6–8</c:v>
                </c:pt>
                <c:pt idx="3">
                  <c:v>9–11</c:v>
                </c:pt>
                <c:pt idx="4">
                  <c:v>12–14</c:v>
                </c:pt>
                <c:pt idx="5">
                  <c:v>15–17</c:v>
                </c:pt>
                <c:pt idx="6">
                  <c:v>18–20</c:v>
                </c:pt>
                <c:pt idx="7">
                  <c:v>21–23</c:v>
                </c:pt>
                <c:pt idx="8">
                  <c:v>24–26</c:v>
                </c:pt>
                <c:pt idx="9">
                  <c:v>27–29</c:v>
                </c:pt>
                <c:pt idx="10">
                  <c:v>30–32</c:v>
                </c:pt>
                <c:pt idx="11">
                  <c:v>33–35</c:v>
                </c:pt>
                <c:pt idx="12">
                  <c:v>36–38</c:v>
                </c:pt>
                <c:pt idx="13">
                  <c:v>39–41</c:v>
                </c:pt>
                <c:pt idx="14">
                  <c:v>42–44</c:v>
                </c:pt>
                <c:pt idx="15">
                  <c:v>45–47</c:v>
                </c:pt>
                <c:pt idx="16">
                  <c:v>48–50</c:v>
                </c:pt>
                <c:pt idx="17">
                  <c:v>51–53</c:v>
                </c:pt>
                <c:pt idx="18">
                  <c:v>54–56</c:v>
                </c:pt>
                <c:pt idx="19">
                  <c:v>57–59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流行期別インシデンス!$P$33:$P$53</c15:sqref>
                  </c15:fullRef>
                </c:ext>
              </c:extLst>
              <c:f>流行期別インシデンス!$P$34:$P$53</c:f>
              <c:numCache>
                <c:formatCode>0.0</c:formatCode>
                <c:ptCount val="20"/>
                <c:pt idx="0">
                  <c:v>35.907392843098698</c:v>
                </c:pt>
                <c:pt idx="1">
                  <c:v>115.74194105954543</c:v>
                </c:pt>
                <c:pt idx="2">
                  <c:v>29.031104281475201</c:v>
                </c:pt>
                <c:pt idx="3">
                  <c:v>53.078376283665953</c:v>
                </c:pt>
                <c:pt idx="4">
                  <c:v>84.857003461654628</c:v>
                </c:pt>
                <c:pt idx="5">
                  <c:v>71.064919904014531</c:v>
                </c:pt>
                <c:pt idx="6">
                  <c:v>98.851854936086937</c:v>
                </c:pt>
                <c:pt idx="7">
                  <c:v>32.052125839147031</c:v>
                </c:pt>
                <c:pt idx="8">
                  <c:v>16.308351751389726</c:v>
                </c:pt>
                <c:pt idx="9">
                  <c:v>16.674655892624806</c:v>
                </c:pt>
                <c:pt idx="10">
                  <c:v>16.08853650479022</c:v>
                </c:pt>
                <c:pt idx="11">
                  <c:v>7.6266939508467146</c:v>
                </c:pt>
                <c:pt idx="12">
                  <c:v>7.531548993731441</c:v>
                </c:pt>
                <c:pt idx="13">
                  <c:v>7.4130827464431404</c:v>
                </c:pt>
                <c:pt idx="14">
                  <c:v>7.6852670117409412</c:v>
                </c:pt>
                <c:pt idx="15">
                  <c:v>0</c:v>
                </c:pt>
                <c:pt idx="16">
                  <c:v>8.3533447684391078</c:v>
                </c:pt>
                <c:pt idx="17">
                  <c:v>25.457692486408625</c:v>
                </c:pt>
                <c:pt idx="18">
                  <c:v>8.8137351897878915</c:v>
                </c:pt>
                <c:pt idx="1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AE-42B9-84E3-827132820E0C}"/>
            </c:ext>
          </c:extLst>
        </c:ser>
        <c:ser>
          <c:idx val="13"/>
          <c:order val="13"/>
          <c:tx>
            <c:strRef>
              <c:f>流行期別インシデンス!$Q$32</c:f>
              <c:strCache>
                <c:ptCount val="1"/>
                <c:pt idx="0">
                  <c:v>RSV-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extLst>
                <c:ext xmlns:c15="http://schemas.microsoft.com/office/drawing/2012/chart" uri="{02D57815-91ED-43cb-92C2-25804820EDAC}">
                  <c15:fullRef>
                    <c15:sqref>流行期別インシデンス!$B$33:$B$53</c15:sqref>
                  </c15:fullRef>
                </c:ext>
              </c:extLst>
              <c:f>流行期別インシデンス!$B$34:$B$53</c:f>
              <c:strCache>
                <c:ptCount val="20"/>
                <c:pt idx="0">
                  <c:v>2</c:v>
                </c:pt>
                <c:pt idx="1">
                  <c:v>3–5</c:v>
                </c:pt>
                <c:pt idx="2">
                  <c:v>6–8</c:v>
                </c:pt>
                <c:pt idx="3">
                  <c:v>9–11</c:v>
                </c:pt>
                <c:pt idx="4">
                  <c:v>12–14</c:v>
                </c:pt>
                <c:pt idx="5">
                  <c:v>15–17</c:v>
                </c:pt>
                <c:pt idx="6">
                  <c:v>18–20</c:v>
                </c:pt>
                <c:pt idx="7">
                  <c:v>21–23</c:v>
                </c:pt>
                <c:pt idx="8">
                  <c:v>24–26</c:v>
                </c:pt>
                <c:pt idx="9">
                  <c:v>27–29</c:v>
                </c:pt>
                <c:pt idx="10">
                  <c:v>30–32</c:v>
                </c:pt>
                <c:pt idx="11">
                  <c:v>33–35</c:v>
                </c:pt>
                <c:pt idx="12">
                  <c:v>36–38</c:v>
                </c:pt>
                <c:pt idx="13">
                  <c:v>39–41</c:v>
                </c:pt>
                <c:pt idx="14">
                  <c:v>42–44</c:v>
                </c:pt>
                <c:pt idx="15">
                  <c:v>45–47</c:v>
                </c:pt>
                <c:pt idx="16">
                  <c:v>48–50</c:v>
                </c:pt>
                <c:pt idx="17">
                  <c:v>51–53</c:v>
                </c:pt>
                <c:pt idx="18">
                  <c:v>54–56</c:v>
                </c:pt>
                <c:pt idx="19">
                  <c:v>57–59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流行期別インシデンス!$Q$33:$Q$53</c15:sqref>
                  </c15:fullRef>
                </c:ext>
              </c:extLst>
              <c:f>流行期別インシデンス!$Q$34:$Q$53</c:f>
              <c:numCache>
                <c:formatCode>0.0</c:formatCode>
                <c:ptCount val="20"/>
                <c:pt idx="0">
                  <c:v>0</c:v>
                </c:pt>
                <c:pt idx="1">
                  <c:v>42.087978567107427</c:v>
                </c:pt>
                <c:pt idx="2">
                  <c:v>29.031104281475201</c:v>
                </c:pt>
                <c:pt idx="3">
                  <c:v>8.8463960472776595</c:v>
                </c:pt>
                <c:pt idx="4">
                  <c:v>33.942801384661848</c:v>
                </c:pt>
                <c:pt idx="5">
                  <c:v>23.688306634671509</c:v>
                </c:pt>
                <c:pt idx="6">
                  <c:v>22.811966523712371</c:v>
                </c:pt>
                <c:pt idx="7">
                  <c:v>16.026062919573516</c:v>
                </c:pt>
                <c:pt idx="8">
                  <c:v>8.1541758756948628</c:v>
                </c:pt>
                <c:pt idx="9">
                  <c:v>0</c:v>
                </c:pt>
                <c:pt idx="10">
                  <c:v>0</c:v>
                </c:pt>
                <c:pt idx="11">
                  <c:v>7.6266939508467146</c:v>
                </c:pt>
                <c:pt idx="12">
                  <c:v>0</c:v>
                </c:pt>
                <c:pt idx="13">
                  <c:v>7.4130827464431404</c:v>
                </c:pt>
                <c:pt idx="14">
                  <c:v>0</c:v>
                </c:pt>
                <c:pt idx="15">
                  <c:v>0</c:v>
                </c:pt>
                <c:pt idx="16">
                  <c:v>8.3533447684391078</c:v>
                </c:pt>
                <c:pt idx="17">
                  <c:v>0</c:v>
                </c:pt>
                <c:pt idx="18">
                  <c:v>8.8137351897878915</c:v>
                </c:pt>
                <c:pt idx="19">
                  <c:v>8.7878642061448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AE-42B9-84E3-827132820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81621584"/>
        <c:axId val="446119888"/>
        <c:extLst>
          <c:ext xmlns:c15="http://schemas.microsoft.com/office/drawing/2012/chart" uri="{02D57815-91ED-43cb-92C2-25804820EDAC}">
            <c15:filteredBarSeries>
              <c15:ser>
                <c:idx val="4"/>
                <c:order val="0"/>
                <c:tx>
                  <c:strRef>
                    <c:extLst>
                      <c:ext uri="{02D57815-91ED-43cb-92C2-25804820EDAC}">
                        <c15:formulaRef>
                          <c15:sqref>流行期別インシデンス!$G$32</c15:sqref>
                        </c15:formulaRef>
                      </c:ext>
                    </c:extLst>
                    <c:strCache>
                      <c:ptCount val="1"/>
                      <c:pt idx="0">
                        <c:v>Undefined RTI</c:v>
                      </c:pt>
                    </c:strCache>
                  </c:strRef>
                </c:tx>
                <c:spPr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ullRef>
                          <c15:sqref>流行期別インシデンス!$G$33:$G$53</c15:sqref>
                        </c15:fullRef>
                        <c15:formulaRef>
                          <c15:sqref>流行期別インシデンス!$G$34:$G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0</c:v>
                      </c:pt>
                      <c:pt idx="2">
                        <c:v>0</c:v>
                      </c:pt>
                      <c:pt idx="3">
                        <c:v>0</c:v>
                      </c:pt>
                      <c:pt idx="4">
                        <c:v>0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0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2DAE-42B9-84E3-827132820E0C}"/>
                  </c:ext>
                </c:extLst>
              </c15:ser>
            </c15:filteredBarSeries>
            <c15:filteredBarSeries>
              <c15:ser>
                <c:idx val="0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C$32</c15:sqref>
                        </c15:formulaRef>
                      </c:ext>
                    </c:extLst>
                    <c:strCache>
                      <c:ptCount val="1"/>
                      <c:pt idx="0">
                        <c:v>RTI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C$33:$C$53</c15:sqref>
                        </c15:fullRef>
                        <c15:formulaRef>
                          <c15:sqref>流行期別インシデンス!$C$34:$C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52.609973208884284</c:v>
                      </c:pt>
                      <c:pt idx="2">
                        <c:v>9.6770347604917344</c:v>
                      </c:pt>
                      <c:pt idx="3">
                        <c:v>44.231980236388296</c:v>
                      </c:pt>
                      <c:pt idx="4">
                        <c:v>16.971400692330924</c:v>
                      </c:pt>
                      <c:pt idx="5">
                        <c:v>15.79220442311434</c:v>
                      </c:pt>
                      <c:pt idx="6">
                        <c:v>7.6039888412374568</c:v>
                      </c:pt>
                      <c:pt idx="7">
                        <c:v>24.039094379360272</c:v>
                      </c:pt>
                      <c:pt idx="8">
                        <c:v>16.308351751389726</c:v>
                      </c:pt>
                      <c:pt idx="9">
                        <c:v>25.011983838937205</c:v>
                      </c:pt>
                      <c:pt idx="10">
                        <c:v>16.08853650479022</c:v>
                      </c:pt>
                      <c:pt idx="11">
                        <c:v>15.253387901693429</c:v>
                      </c:pt>
                      <c:pt idx="12">
                        <c:v>0</c:v>
                      </c:pt>
                      <c:pt idx="13">
                        <c:v>14.826165492886281</c:v>
                      </c:pt>
                      <c:pt idx="14">
                        <c:v>23.055801035222824</c:v>
                      </c:pt>
                      <c:pt idx="15">
                        <c:v>0</c:v>
                      </c:pt>
                      <c:pt idx="16">
                        <c:v>8.3533447684391078</c:v>
                      </c:pt>
                      <c:pt idx="17">
                        <c:v>16.971794990939081</c:v>
                      </c:pt>
                      <c:pt idx="18">
                        <c:v>8.8137351897878915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2DAE-42B9-84E3-827132820E0C}"/>
                  </c:ext>
                </c:extLst>
              </c15:ser>
            </c15:filteredBarSeries>
            <c15:filteredBarSeries>
              <c15:ser>
                <c:idx val="1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D$32</c15:sqref>
                        </c15:formulaRef>
                      </c:ext>
                    </c:extLst>
                    <c:strCache>
                      <c:ptCount val="1"/>
                      <c:pt idx="0">
                        <c:v>LRTI</c:v>
                      </c:pt>
                    </c:strCache>
                  </c:strRef>
                </c:tx>
                <c:spPr>
                  <a:pattFill prst="pct20">
                    <a:fgClr>
                      <a:schemeClr val="tx1"/>
                    </a:fgClr>
                    <a:bgClr>
                      <a:schemeClr val="bg1"/>
                    </a:bgClr>
                  </a:patt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D$33:$D$53</c15:sqref>
                        </c15:fullRef>
                        <c15:formulaRef>
                          <c15:sqref>流行期別インシデンス!$D$34:$D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35.907392843098698</c:v>
                      </c:pt>
                      <c:pt idx="1">
                        <c:v>52.609973208884284</c:v>
                      </c:pt>
                      <c:pt idx="2">
                        <c:v>9.6770347604917344</c:v>
                      </c:pt>
                      <c:pt idx="3">
                        <c:v>17.692792094555319</c:v>
                      </c:pt>
                      <c:pt idx="4">
                        <c:v>42.428501730827314</c:v>
                      </c:pt>
                      <c:pt idx="5">
                        <c:v>31.58440884622868</c:v>
                      </c:pt>
                      <c:pt idx="6">
                        <c:v>53.227921888662195</c:v>
                      </c:pt>
                      <c:pt idx="7">
                        <c:v>24.039094379360272</c:v>
                      </c:pt>
                      <c:pt idx="8">
                        <c:v>16.308351751389726</c:v>
                      </c:pt>
                      <c:pt idx="9">
                        <c:v>16.674655892624806</c:v>
                      </c:pt>
                      <c:pt idx="10">
                        <c:v>8.0442682523951099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7.4130827464431404</c:v>
                      </c:pt>
                      <c:pt idx="14">
                        <c:v>7.6852670117409412</c:v>
                      </c:pt>
                      <c:pt idx="15">
                        <c:v>0</c:v>
                      </c:pt>
                      <c:pt idx="16">
                        <c:v>8.3533447684391078</c:v>
                      </c:pt>
                      <c:pt idx="17">
                        <c:v>25.457692486408625</c:v>
                      </c:pt>
                      <c:pt idx="18">
                        <c:v>8.8137351897878915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2DAE-42B9-84E3-827132820E0C}"/>
                  </c:ext>
                </c:extLst>
              </c15:ser>
            </c15:filteredBarSeries>
            <c15:filteredBarSeries>
              <c15:ser>
                <c:idx val="2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E$32</c15:sqref>
                        </c15:formulaRef>
                      </c:ext>
                    </c:extLst>
                    <c:strCache>
                      <c:ptCount val="1"/>
                      <c:pt idx="0">
                        <c:v>Severe LRTI</c:v>
                      </c:pt>
                    </c:strCache>
                  </c:strRef>
                </c:tx>
                <c:spPr>
                  <a:pattFill prst="pct60">
                    <a:fgClr>
                      <a:schemeClr val="tx1"/>
                    </a:fgClr>
                    <a:bgClr>
                      <a:schemeClr val="bg1"/>
                    </a:bgClr>
                  </a:patt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E$33:$E$53</c15:sqref>
                        </c15:fullRef>
                        <c15:formulaRef>
                          <c15:sqref>流行期別インシデンス!$E$34:$E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42.087978567107427</c:v>
                      </c:pt>
                      <c:pt idx="2">
                        <c:v>9.6770347604917344</c:v>
                      </c:pt>
                      <c:pt idx="3">
                        <c:v>17.692792094555319</c:v>
                      </c:pt>
                      <c:pt idx="4">
                        <c:v>33.942801384661848</c:v>
                      </c:pt>
                      <c:pt idx="5">
                        <c:v>39.480511057785847</c:v>
                      </c:pt>
                      <c:pt idx="6">
                        <c:v>45.623933047424742</c:v>
                      </c:pt>
                      <c:pt idx="7">
                        <c:v>8.0130314597867578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7.6266939508467146</c:v>
                      </c:pt>
                      <c:pt idx="12">
                        <c:v>7.531548993731441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2DAE-42B9-84E3-827132820E0C}"/>
                  </c:ext>
                </c:extLst>
              </c15:ser>
            </c15:filteredBarSeries>
            <c15:filteredBarSeries>
              <c15:ser>
                <c:idx val="3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F$32</c15:sqref>
                        </c15:formulaRef>
                      </c:ext>
                    </c:extLst>
                    <c:strCache>
                      <c:ptCount val="1"/>
                      <c:pt idx="0">
                        <c:v>Very severe LRTI</c:v>
                      </c:pt>
                    </c:strCache>
                  </c:strRef>
                </c:tx>
                <c:spPr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F$33:$F$53</c15:sqref>
                        </c15:fullRef>
                        <c15:formulaRef>
                          <c15:sqref>流行期別インシデンス!$F$34:$F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21.043989283553714</c:v>
                      </c:pt>
                      <c:pt idx="2">
                        <c:v>9.6770347604917344</c:v>
                      </c:pt>
                      <c:pt idx="3">
                        <c:v>17.692792094555319</c:v>
                      </c:pt>
                      <c:pt idx="4">
                        <c:v>8.4857003461654621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0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8.0442682523951099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2DAE-42B9-84E3-827132820E0C}"/>
                  </c:ext>
                </c:extLst>
              </c15:ser>
            </c15:filteredBarSeries>
            <c15:filteredBarSeries>
              <c15:ser>
                <c:idx val="9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L$32</c15:sqref>
                        </c15:formulaRef>
                      </c:ext>
                    </c:extLst>
                    <c:strCache>
                      <c:ptCount val="1"/>
                      <c:pt idx="0">
                        <c:v>Undefined RTI</c:v>
                      </c:pt>
                    </c:strCache>
                  </c:strRef>
                </c:tx>
                <c:spPr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L$33:$L$53</c15:sqref>
                        </c15:fullRef>
                        <c15:formulaRef>
                          <c15:sqref>流行期別インシデンス!$L$34:$L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0</c:v>
                      </c:pt>
                      <c:pt idx="2">
                        <c:v>0</c:v>
                      </c:pt>
                      <c:pt idx="3">
                        <c:v>0</c:v>
                      </c:pt>
                      <c:pt idx="4">
                        <c:v>0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0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2DAE-42B9-84E3-827132820E0C}"/>
                  </c:ext>
                </c:extLst>
              </c15:ser>
            </c15:filteredBarSeries>
            <c15:filteredBarSeries>
              <c15:ser>
                <c:idx val="5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H$32</c15:sqref>
                        </c15:formulaRef>
                      </c:ext>
                    </c:extLst>
                    <c:strCache>
                      <c:ptCount val="1"/>
                      <c:pt idx="0">
                        <c:v>RTI</c:v>
                      </c:pt>
                    </c:strCache>
                  </c:strRef>
                </c:tx>
                <c:spPr>
                  <a:solidFill>
                    <a:schemeClr val="accent6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H$33:$H$53</c15:sqref>
                        </c15:fullRef>
                        <c15:formulaRef>
                          <c15:sqref>流行期別インシデンス!$H$34:$H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35.907392843098698</c:v>
                      </c:pt>
                      <c:pt idx="1">
                        <c:v>21.043989283553714</c:v>
                      </c:pt>
                      <c:pt idx="2">
                        <c:v>19.354069520983469</c:v>
                      </c:pt>
                      <c:pt idx="3">
                        <c:v>8.8463960472776595</c:v>
                      </c:pt>
                      <c:pt idx="4">
                        <c:v>16.971400692330924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8.0130314597867578</c:v>
                      </c:pt>
                      <c:pt idx="8">
                        <c:v>0</c:v>
                      </c:pt>
                      <c:pt idx="9">
                        <c:v>8.3373279463124028</c:v>
                      </c:pt>
                      <c:pt idx="10">
                        <c:v>8.0442682523951099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7.6852670117409412</c:v>
                      </c:pt>
                      <c:pt idx="15">
                        <c:v>0</c:v>
                      </c:pt>
                      <c:pt idx="16">
                        <c:v>8.3533447684391078</c:v>
                      </c:pt>
                      <c:pt idx="17">
                        <c:v>8.4858974954695405</c:v>
                      </c:pt>
                      <c:pt idx="18">
                        <c:v>0</c:v>
                      </c:pt>
                      <c:pt idx="19">
                        <c:v>17.575728412289777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2DAE-42B9-84E3-827132820E0C}"/>
                  </c:ext>
                </c:extLst>
              </c15:ser>
            </c15:filteredBarSeries>
            <c15:filteredBarSeries>
              <c15:ser>
                <c:idx val="6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I$32</c15:sqref>
                        </c15:formulaRef>
                      </c:ext>
                    </c:extLst>
                    <c:strCache>
                      <c:ptCount val="1"/>
                      <c:pt idx="0">
                        <c:v>LRTI</c:v>
                      </c:pt>
                    </c:strCache>
                  </c:strRef>
                </c:tx>
                <c:spPr>
                  <a:pattFill prst="pct20">
                    <a:fgClr>
                      <a:schemeClr val="tx1"/>
                    </a:fgClr>
                    <a:bgClr>
                      <a:schemeClr val="bg1"/>
                    </a:bgClr>
                  </a:patt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I$33:$I$53</c15:sqref>
                        </c15:fullRef>
                        <c15:formulaRef>
                          <c15:sqref>流行期別インシデンス!$I$34:$I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21.043989283553714</c:v>
                      </c:pt>
                      <c:pt idx="2">
                        <c:v>19.354069520983469</c:v>
                      </c:pt>
                      <c:pt idx="3">
                        <c:v>0</c:v>
                      </c:pt>
                      <c:pt idx="4">
                        <c:v>8.4857003461654621</c:v>
                      </c:pt>
                      <c:pt idx="5">
                        <c:v>15.79220442311434</c:v>
                      </c:pt>
                      <c:pt idx="6">
                        <c:v>7.6039888412374568</c:v>
                      </c:pt>
                      <c:pt idx="7">
                        <c:v>8.0130314597867578</c:v>
                      </c:pt>
                      <c:pt idx="8">
                        <c:v>8.1541758756948628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7.4130827464431404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8.3533447684391078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2DAE-42B9-84E3-827132820E0C}"/>
                  </c:ext>
                </c:extLst>
              </c15:ser>
            </c15:filteredBarSeries>
            <c15:filteredBarSeries>
              <c15:ser>
                <c:idx val="7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J$32</c15:sqref>
                        </c15:formulaRef>
                      </c:ext>
                    </c:extLst>
                    <c:strCache>
                      <c:ptCount val="1"/>
                      <c:pt idx="0">
                        <c:v>Severe LRTI</c:v>
                      </c:pt>
                    </c:strCache>
                  </c:strRef>
                </c:tx>
                <c:spPr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J$33:$J$53</c15:sqref>
                        </c15:fullRef>
                        <c15:formulaRef>
                          <c15:sqref>流行期別インシデンス!$J$34:$J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10.521994641776857</c:v>
                      </c:pt>
                      <c:pt idx="2">
                        <c:v>0</c:v>
                      </c:pt>
                      <c:pt idx="3">
                        <c:v>0</c:v>
                      </c:pt>
                      <c:pt idx="4">
                        <c:v>8.4857003461654621</c:v>
                      </c:pt>
                      <c:pt idx="5">
                        <c:v>7.89610221155717</c:v>
                      </c:pt>
                      <c:pt idx="6">
                        <c:v>15.207977682474914</c:v>
                      </c:pt>
                      <c:pt idx="7">
                        <c:v>0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8.8137351897878915</c:v>
                      </c:pt>
                      <c:pt idx="19">
                        <c:v>8.7878642061448886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2DAE-42B9-84E3-827132820E0C}"/>
                  </c:ext>
                </c:extLst>
              </c15:ser>
            </c15:filteredBarSeries>
            <c15:filteredBarSeries>
              <c15:ser>
                <c:idx val="8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K$32</c15:sqref>
                        </c15:formulaRef>
                      </c:ext>
                    </c:extLst>
                    <c:strCache>
                      <c:ptCount val="1"/>
                      <c:pt idx="0">
                        <c:v>Very severe LRTI</c:v>
                      </c:pt>
                    </c:strCache>
                  </c:strRef>
                </c:tx>
                <c:spPr>
                  <a:pattFill prst="pct60">
                    <a:fgClr>
                      <a:schemeClr val="tx1"/>
                    </a:fgClr>
                    <a:bgClr>
                      <a:schemeClr val="bg1"/>
                    </a:bgClr>
                  </a:patt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K$33:$K$53</c15:sqref>
                        </c15:fullRef>
                        <c15:formulaRef>
                          <c15:sqref>流行期別インシデンス!$K$34:$K$53</c15:sqref>
                        </c15:formulaRef>
                      </c:ext>
                    </c:extLst>
                    <c:numCache>
                      <c:formatCode>0.00</c:formatCode>
                      <c:ptCount val="20"/>
                      <c:pt idx="0">
                        <c:v>0</c:v>
                      </c:pt>
                      <c:pt idx="1">
                        <c:v>10.521994641776857</c:v>
                      </c:pt>
                      <c:pt idx="2">
                        <c:v>9.6770347604917344</c:v>
                      </c:pt>
                      <c:pt idx="3">
                        <c:v>8.8463960472776595</c:v>
                      </c:pt>
                      <c:pt idx="4">
                        <c:v>16.971400692330924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8.0130314597867578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7.6266939508467146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2DAE-42B9-84E3-827132820E0C}"/>
                  </c:ext>
                </c:extLst>
              </c15:ser>
            </c15:filteredBarSeries>
            <c15:filteredBarSeries>
              <c15:ser>
                <c:idx val="11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N$32</c15:sqref>
                        </c15:formulaRef>
                      </c:ext>
                    </c:extLst>
                    <c:strCache>
                      <c:ptCount val="1"/>
                      <c:pt idx="0">
                        <c:v>Epidemic period</c:v>
                      </c:pt>
                    </c:strCache>
                  </c:strRef>
                </c:tx>
                <c:spPr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N$33:$N$53</c15:sqref>
                        </c15:fullRef>
                        <c15:formulaRef>
                          <c15:sqref>流行期別インシデンス!$N$34:$N$53</c15:sqref>
                        </c15:formulaRef>
                      </c:ext>
                    </c:extLst>
                    <c:numCache>
                      <c:formatCode>0</c:formatCode>
                      <c:ptCount val="20"/>
                      <c:pt idx="0">
                        <c:v>44</c:v>
                      </c:pt>
                      <c:pt idx="1">
                        <c:v>71.42505133470226</c:v>
                      </c:pt>
                      <c:pt idx="2">
                        <c:v>80.197125256673516</c:v>
                      </c:pt>
                      <c:pt idx="3">
                        <c:v>83.186858316221759</c:v>
                      </c:pt>
                      <c:pt idx="4">
                        <c:v>91.192334017796028</c:v>
                      </c:pt>
                      <c:pt idx="5">
                        <c:v>95.028062970568101</c:v>
                      </c:pt>
                      <c:pt idx="6">
                        <c:v>103.00342231348391</c:v>
                      </c:pt>
                      <c:pt idx="7">
                        <c:v>95.956194387405887</c:v>
                      </c:pt>
                      <c:pt idx="8">
                        <c:v>91.60848733744011</c:v>
                      </c:pt>
                      <c:pt idx="9">
                        <c:v>86.543463381245715</c:v>
                      </c:pt>
                      <c:pt idx="10">
                        <c:v>94.707734428473643</c:v>
                      </c:pt>
                      <c:pt idx="11">
                        <c:v>101.52224503764545</c:v>
                      </c:pt>
                      <c:pt idx="12">
                        <c:v>105.75770020533881</c:v>
                      </c:pt>
                      <c:pt idx="13">
                        <c:v>98.130047912388775</c:v>
                      </c:pt>
                      <c:pt idx="14">
                        <c:v>96.714579055441476</c:v>
                      </c:pt>
                      <c:pt idx="15">
                        <c:v>94.368240930869263</c:v>
                      </c:pt>
                      <c:pt idx="16">
                        <c:v>90.255989048596845</c:v>
                      </c:pt>
                      <c:pt idx="17">
                        <c:v>84.843258042436688</c:v>
                      </c:pt>
                      <c:pt idx="18">
                        <c:v>86.98699520876113</c:v>
                      </c:pt>
                      <c:pt idx="19">
                        <c:v>88.763860369609858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2DAE-42B9-84E3-827132820E0C}"/>
                  </c:ext>
                </c:extLst>
              </c15:ser>
            </c15:filteredBarSeries>
            <c15:filteredBarSeries>
              <c15:ser>
                <c:idx val="10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流行期別インシデンス!$M$32</c15:sqref>
                        </c15:formulaRef>
                      </c:ext>
                    </c:extLst>
                    <c:strCache>
                      <c:ptCount val="1"/>
                      <c:pt idx="0">
                        <c:v>Not epidemic period</c:v>
                      </c:pt>
                    </c:strCache>
                  </c:strRef>
                </c:tx>
                <c:spPr>
                  <a:solidFill>
                    <a:schemeClr val="bg2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B$33:$B$53</c15:sqref>
                        </c15:fullRef>
                        <c15:formulaRef>
                          <c15:sqref>流行期別インシデンス!$B$34:$B$53</c15:sqref>
                        </c15:formulaRef>
                      </c:ext>
                    </c:extLst>
                    <c:strCache>
                      <c:ptCount val="20"/>
                      <c:pt idx="0">
                        <c:v>2</c:v>
                      </c:pt>
                      <c:pt idx="1">
                        <c:v>3–5</c:v>
                      </c:pt>
                      <c:pt idx="2">
                        <c:v>6–8</c:v>
                      </c:pt>
                      <c:pt idx="3">
                        <c:v>9–11</c:v>
                      </c:pt>
                      <c:pt idx="4">
                        <c:v>12–14</c:v>
                      </c:pt>
                      <c:pt idx="5">
                        <c:v>15–17</c:v>
                      </c:pt>
                      <c:pt idx="6">
                        <c:v>18–20</c:v>
                      </c:pt>
                      <c:pt idx="7">
                        <c:v>21–23</c:v>
                      </c:pt>
                      <c:pt idx="8">
                        <c:v>24–26</c:v>
                      </c:pt>
                      <c:pt idx="9">
                        <c:v>27–29</c:v>
                      </c:pt>
                      <c:pt idx="10">
                        <c:v>30–32</c:v>
                      </c:pt>
                      <c:pt idx="11">
                        <c:v>33–35</c:v>
                      </c:pt>
                      <c:pt idx="12">
                        <c:v>36–38</c:v>
                      </c:pt>
                      <c:pt idx="13">
                        <c:v>39–41</c:v>
                      </c:pt>
                      <c:pt idx="14">
                        <c:v>42–44</c:v>
                      </c:pt>
                      <c:pt idx="15">
                        <c:v>45–47</c:v>
                      </c:pt>
                      <c:pt idx="16">
                        <c:v>48–50</c:v>
                      </c:pt>
                      <c:pt idx="17">
                        <c:v>51–53</c:v>
                      </c:pt>
                      <c:pt idx="18">
                        <c:v>54–56</c:v>
                      </c:pt>
                      <c:pt idx="19">
                        <c:v>57–59</c:v>
                      </c:pt>
                    </c:strCache>
                  </c:strRef>
                </c:cat>
                <c:val>
                  <c:numRef>
                    <c:extLst>
                      <c:ext xmlns:c15="http://schemas.microsoft.com/office/drawing/2012/chart" uri="{02D57815-91ED-43cb-92C2-25804820EDAC}">
                        <c15:fullRef>
                          <c15:sqref>流行期別インシデンス!$M$33:$M$53</c15:sqref>
                        </c15:fullRef>
                        <c15:formulaRef>
                          <c15:sqref>流行期別インシデンス!$M$34:$M$53</c15:sqref>
                        </c15:formulaRef>
                      </c:ext>
                    </c:extLst>
                    <c:numCache>
                      <c:formatCode>0</c:formatCode>
                      <c:ptCount val="20"/>
                      <c:pt idx="0">
                        <c:v>15</c:v>
                      </c:pt>
                      <c:pt idx="1">
                        <c:v>23.613963039014372</c:v>
                      </c:pt>
                      <c:pt idx="2">
                        <c:v>23.140314852840522</c:v>
                      </c:pt>
                      <c:pt idx="3">
                        <c:v>29.853524982888434</c:v>
                      </c:pt>
                      <c:pt idx="4">
                        <c:v>26.652977412731005</c:v>
                      </c:pt>
                      <c:pt idx="5">
                        <c:v>31.616700889801507</c:v>
                      </c:pt>
                      <c:pt idx="6">
                        <c:v>28.506502395619439</c:v>
                      </c:pt>
                      <c:pt idx="7">
                        <c:v>28.840520191649556</c:v>
                      </c:pt>
                      <c:pt idx="8">
                        <c:v>31.028062970568104</c:v>
                      </c:pt>
                      <c:pt idx="9">
                        <c:v>33.399041752224505</c:v>
                      </c:pt>
                      <c:pt idx="10">
                        <c:v>29.604380561259411</c:v>
                      </c:pt>
                      <c:pt idx="11">
                        <c:v>29.596167008898014</c:v>
                      </c:pt>
                      <c:pt idx="12">
                        <c:v>27.017111567419576</c:v>
                      </c:pt>
                      <c:pt idx="13">
                        <c:v>36.766598220396986</c:v>
                      </c:pt>
                      <c:pt idx="14">
                        <c:v>33.404517453798768</c:v>
                      </c:pt>
                      <c:pt idx="15">
                        <c:v>27.249828884325805</c:v>
                      </c:pt>
                      <c:pt idx="16">
                        <c:v>29.456536618754278</c:v>
                      </c:pt>
                      <c:pt idx="17">
                        <c:v>32.999315537303218</c:v>
                      </c:pt>
                      <c:pt idx="18">
                        <c:v>26.472279260780287</c:v>
                      </c:pt>
                      <c:pt idx="19">
                        <c:v>25.02943189596167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2DAE-42B9-84E3-827132820E0C}"/>
                  </c:ext>
                </c:extLst>
              </c15:ser>
            </c15:filteredBarSeries>
          </c:ext>
        </c:extLst>
      </c:barChart>
      <c:catAx>
        <c:axId val="1816215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Age in month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6119888"/>
        <c:crosses val="autoZero"/>
        <c:auto val="1"/>
        <c:lblAlgn val="ctr"/>
        <c:lblOffset val="100"/>
        <c:noMultiLvlLbl val="0"/>
      </c:catAx>
      <c:valAx>
        <c:axId val="446119888"/>
        <c:scaling>
          <c:orientation val="minMax"/>
          <c:max val="3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InIncidence rate (1,000 child-years)</a:t>
                </a:r>
                <a:endParaRPr lang="ja-JP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2158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1164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330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5451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370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295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226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899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4205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248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771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002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C1EFB-CE80-4D2E-BB92-068075D7D7A1}" type="datetimeFigureOut">
              <a:rPr kumimoji="1" lang="ja-JP" altLang="en-US" smtClean="0"/>
              <a:t>2019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82696-4D91-499F-B8CA-521E1AAB2B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817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430C353-1314-4A59-8809-DFA0FF6620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630" y="0"/>
            <a:ext cx="970274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9590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F8CD561-0C86-442E-94BB-B436D8576D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630" y="0"/>
            <a:ext cx="970274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7005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AAD1712-1600-43CB-8889-4EC30B7415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630" y="0"/>
            <a:ext cx="970274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3696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1AD6304-8DAD-4E2D-A878-2A9092BACD2F}"/>
              </a:ext>
            </a:extLst>
          </p:cNvPr>
          <p:cNvSpPr txBox="1"/>
          <p:nvPr/>
        </p:nvSpPr>
        <p:spPr>
          <a:xfrm>
            <a:off x="551401" y="395785"/>
            <a:ext cx="412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2a</a:t>
            </a:r>
            <a:endParaRPr kumimoji="1" lang="ja-JP" altLang="en-US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47DA1BE-848A-4133-A3CE-A3E5B6A78234}"/>
              </a:ext>
            </a:extLst>
          </p:cNvPr>
          <p:cNvSpPr/>
          <p:nvPr/>
        </p:nvSpPr>
        <p:spPr>
          <a:xfrm>
            <a:off x="963693" y="6294032"/>
            <a:ext cx="4953000" cy="40536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SV: respiratory syncytial virus. LRTI: lower respiratory tract illness.</a:t>
            </a:r>
            <a:endParaRPr lang="ja-JP" altLang="ja-JP" sz="1200" kern="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A6CF6ECE-0C58-41FB-829B-35A884C924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7014653"/>
              </p:ext>
            </p:extLst>
          </p:nvPr>
        </p:nvGraphicFramePr>
        <p:xfrm>
          <a:off x="633001" y="729000"/>
          <a:ext cx="8639999" cy="5400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67527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35</Words>
  <Application>Microsoft Office PowerPoint</Application>
  <PresentationFormat>A4 210 x 297 mm</PresentationFormat>
  <Paragraphs>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上野 史彦</dc:creator>
  <cp:lastModifiedBy>Fumihiko Ueno</cp:lastModifiedBy>
  <cp:revision>10</cp:revision>
  <dcterms:created xsi:type="dcterms:W3CDTF">2018-09-16T04:49:11Z</dcterms:created>
  <dcterms:modified xsi:type="dcterms:W3CDTF">2019-01-12T08:17:43Z</dcterms:modified>
</cp:coreProperties>
</file>